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49" d="100"/>
          <a:sy n="149" d="100"/>
        </p:scale>
        <p:origin x="2068" y="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24/06/2026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6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6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6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6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6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6/2026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6/2026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6/2026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6/2026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6/2026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6/2026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24/06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32552" y="5518973"/>
            <a:ext cx="7129237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Said et al (2026) Diabetologia DOI 10.1007/s00125-026-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06785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4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This is a U.S. Government work and not under copyright protection in the US; foreign copyright protection may apply</a:t>
            </a:r>
            <a:endParaRPr kumimoji="0" lang="en-GB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323528" y="516736"/>
            <a:ext cx="2520280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ARS-CoV-2 is associated with pleiotropic effects in the pancreas, insulin-sensitive tissues and immune system, while COVID-19 treatment and containment strategies may modify glucose homeostasis, psychosocial stress levels and diabetes development</a:t>
            </a:r>
            <a:endParaRPr lang="en-GB" sz="1800" b="1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878DB64D-1BC0-6037-4E01-B820B766EA2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03848" y="493899"/>
            <a:ext cx="5239357" cy="52393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9</Words>
  <Application>Microsoft Office PowerPoint</Application>
  <PresentationFormat>On-screen Show (4:3)</PresentationFormat>
  <Paragraphs>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Editorial Office</cp:lastModifiedBy>
  <cp:revision>49</cp:revision>
  <dcterms:created xsi:type="dcterms:W3CDTF">2016-06-15T12:53:43Z</dcterms:created>
  <dcterms:modified xsi:type="dcterms:W3CDTF">2026-06-24T15:02:52Z</dcterms:modified>
</cp:coreProperties>
</file>